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" orient="horz" pos="3984" userDrawn="1">
          <p15:clr>
            <a:srgbClr val="A4A3A4"/>
          </p15:clr>
        </p15:guide>
        <p15:guide id="10" orient="horz" pos="5688" userDrawn="1">
          <p15:clr>
            <a:srgbClr val="A4A3A4"/>
          </p15:clr>
        </p15:guide>
        <p15:guide id="12" pos="2160" userDrawn="1">
          <p15:clr>
            <a:srgbClr val="A4A3A4"/>
          </p15:clr>
        </p15:guide>
        <p15:guide id="32" pos="244">
          <p15:clr>
            <a:srgbClr val="A4A3A4"/>
          </p15:clr>
        </p15:guide>
        <p15:guide id="41" pos="4080" userDrawn="1">
          <p15:clr>
            <a:srgbClr val="A4A3A4"/>
          </p15:clr>
        </p15:guide>
        <p15:guide id="44" orient="horz" pos="1488" userDrawn="1">
          <p15:clr>
            <a:srgbClr val="A4A3A4"/>
          </p15:clr>
        </p15:guide>
        <p15:guide id="45" pos="1464" userDrawn="1">
          <p15:clr>
            <a:srgbClr val="A4A3A4"/>
          </p15:clr>
        </p15:guide>
        <p15:guide id="46" pos="9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e" initials="J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2C0EE2"/>
    <a:srgbClr val="FF00FF"/>
    <a:srgbClr val="0E7C28"/>
    <a:srgbClr val="FA714C"/>
    <a:srgbClr val="D0E8D4"/>
    <a:srgbClr val="98F6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15" autoAdjust="0"/>
    <p:restoredTop sz="87957" autoAdjust="0"/>
  </p:normalViewPr>
  <p:slideViewPr>
    <p:cSldViewPr snapToGrid="0" showGuides="1">
      <p:cViewPr varScale="1">
        <p:scale>
          <a:sx n="84" d="100"/>
          <a:sy n="84" d="100"/>
        </p:scale>
        <p:origin x="3272" y="200"/>
      </p:cViewPr>
      <p:guideLst>
        <p:guide orient="horz" pos="3984"/>
        <p:guide orient="horz" pos="5688"/>
        <p:guide pos="2160"/>
        <p:guide pos="244"/>
        <p:guide pos="4080"/>
        <p:guide orient="horz" pos="1488"/>
        <p:guide pos="1464"/>
        <p:guide pos="9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24B9B2-9A98-44F8-B9A3-CCE9D21813A9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901FE-BE7D-4226-A372-8424301D3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70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A2901FE-BE7D-4226-A372-8424301D3E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651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287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8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4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2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5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49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3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96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959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3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47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02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tiff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tiff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527"/>
          <a:stretch/>
        </p:blipFill>
        <p:spPr bwMode="auto">
          <a:xfrm rot="5400000">
            <a:off x="1042440" y="1276915"/>
            <a:ext cx="499700" cy="875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274277" y="1218460"/>
            <a:ext cx="496501" cy="995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290" y="9525"/>
            <a:ext cx="754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S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028965" y="1129567"/>
            <a:ext cx="991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</a:rPr>
              <a:t>Hyphae on</a:t>
            </a:r>
          </a:p>
          <a:p>
            <a:pPr algn="ctr"/>
            <a:r>
              <a:rPr lang="en-US" sz="900" dirty="0">
                <a:solidFill>
                  <a:prstClr val="black"/>
                </a:solidFill>
              </a:rPr>
              <a:t> leaf surface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4058430" y="1912753"/>
            <a:ext cx="499793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891412" y="1910372"/>
            <a:ext cx="38852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74" t="13244" r="41667" b="44172"/>
          <a:stretch/>
        </p:blipFill>
        <p:spPr>
          <a:xfrm rot="5400000">
            <a:off x="1046439" y="2289889"/>
            <a:ext cx="494461" cy="87485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14" t="12698" r="63165" b="63873"/>
          <a:stretch/>
        </p:blipFill>
        <p:spPr>
          <a:xfrm>
            <a:off x="1742006" y="1466453"/>
            <a:ext cx="874854" cy="49807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11" t="12630" r="63738" b="63940"/>
          <a:stretch/>
        </p:blipFill>
        <p:spPr>
          <a:xfrm>
            <a:off x="1742006" y="1973269"/>
            <a:ext cx="874854" cy="498079"/>
          </a:xfrm>
          <a:prstGeom prst="rect">
            <a:avLst/>
          </a:prstGeom>
        </p:spPr>
      </p:pic>
      <p:cxnSp>
        <p:nvCxnSpPr>
          <p:cNvPr id="18" name="Straight Connector 17"/>
          <p:cNvCxnSpPr/>
          <p:nvPr/>
        </p:nvCxnSpPr>
        <p:spPr>
          <a:xfrm>
            <a:off x="1776490" y="1913164"/>
            <a:ext cx="38852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05" t="9717" r="32974" b="66853"/>
          <a:stretch/>
        </p:blipFill>
        <p:spPr>
          <a:xfrm>
            <a:off x="1742006" y="2480834"/>
            <a:ext cx="874854" cy="49371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09" t="38148" r="35139" b="21876"/>
          <a:stretch/>
        </p:blipFill>
        <p:spPr>
          <a:xfrm>
            <a:off x="2632534" y="1466453"/>
            <a:ext cx="1377491" cy="498078"/>
          </a:xfrm>
          <a:prstGeom prst="rect">
            <a:avLst/>
          </a:prstGeom>
        </p:spPr>
      </p:pic>
      <p:cxnSp>
        <p:nvCxnSpPr>
          <p:cNvPr id="21" name="Straight Connector 20"/>
          <p:cNvCxnSpPr/>
          <p:nvPr/>
        </p:nvCxnSpPr>
        <p:spPr>
          <a:xfrm>
            <a:off x="2659292" y="1911809"/>
            <a:ext cx="33428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64" t="37272" r="35600" b="24590"/>
          <a:stretch/>
        </p:blipFill>
        <p:spPr>
          <a:xfrm>
            <a:off x="2632534" y="1973271"/>
            <a:ext cx="1377491" cy="49807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03" t="62476" r="32777"/>
          <a:stretch/>
        </p:blipFill>
        <p:spPr>
          <a:xfrm>
            <a:off x="2632534" y="2480834"/>
            <a:ext cx="1377491" cy="49371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66" t="17398" r="24791" b="11491"/>
          <a:stretch/>
        </p:blipFill>
        <p:spPr>
          <a:xfrm>
            <a:off x="5035342" y="1466408"/>
            <a:ext cx="1002311" cy="498078"/>
          </a:xfrm>
          <a:prstGeom prst="rect">
            <a:avLst/>
          </a:prstGeom>
        </p:spPr>
      </p:pic>
      <p:cxnSp>
        <p:nvCxnSpPr>
          <p:cNvPr id="25" name="Straight Connector 24"/>
          <p:cNvCxnSpPr/>
          <p:nvPr/>
        </p:nvCxnSpPr>
        <p:spPr>
          <a:xfrm>
            <a:off x="5086234" y="1917699"/>
            <a:ext cx="122223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14" t="17398" r="24722" b="11964"/>
          <a:stretch/>
        </p:blipFill>
        <p:spPr>
          <a:xfrm>
            <a:off x="5035342" y="1973225"/>
            <a:ext cx="1002311" cy="497772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01" t="20509" r="25070" b="12437"/>
          <a:stretch/>
        </p:blipFill>
        <p:spPr>
          <a:xfrm>
            <a:off x="5035343" y="2480789"/>
            <a:ext cx="1002311" cy="493715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293370" y="1656545"/>
            <a:ext cx="51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Merg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82575" y="2052396"/>
            <a:ext cx="791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RP27p:</a:t>
            </a:r>
          </a:p>
          <a:p>
            <a:r>
              <a:rPr lang="en-US" sz="900" dirty="0" err="1"/>
              <a:t>tdTomato</a:t>
            </a:r>
            <a:endParaRPr lang="en-US" sz="900" dirty="0"/>
          </a:p>
        </p:txBody>
      </p:sp>
      <p:sp>
        <p:nvSpPr>
          <p:cNvPr id="30" name="TextBox 29"/>
          <p:cNvSpPr txBox="1"/>
          <p:nvPr/>
        </p:nvSpPr>
        <p:spPr>
          <a:xfrm>
            <a:off x="288925" y="2542340"/>
            <a:ext cx="672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PWL2p:</a:t>
            </a:r>
          </a:p>
          <a:p>
            <a:r>
              <a:rPr lang="en-US" sz="900" dirty="0"/>
              <a:t>EGFP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856243" y="1131985"/>
            <a:ext cx="8748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</a:rPr>
              <a:t>Mycelia in CM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742008" y="1129570"/>
            <a:ext cx="874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>
                <a:solidFill>
                  <a:prstClr val="black"/>
                </a:solidFill>
              </a:rPr>
              <a:t>Conidium</a:t>
            </a:r>
            <a:r>
              <a:rPr lang="en-US" sz="900" dirty="0">
                <a:solidFill>
                  <a:prstClr val="black"/>
                </a:solidFill>
              </a:rPr>
              <a:t> </a:t>
            </a:r>
          </a:p>
          <a:p>
            <a:pPr algn="ctr"/>
            <a:r>
              <a:rPr lang="en-US" sz="900" dirty="0">
                <a:solidFill>
                  <a:prstClr val="black"/>
                </a:solidFill>
              </a:rPr>
              <a:t>on OM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627083" y="1129569"/>
            <a:ext cx="1384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>
                <a:solidFill>
                  <a:prstClr val="black"/>
                </a:solidFill>
              </a:rPr>
              <a:t>Appressorium</a:t>
            </a:r>
            <a:r>
              <a:rPr lang="en-US" sz="900" dirty="0">
                <a:solidFill>
                  <a:prstClr val="black"/>
                </a:solidFill>
              </a:rPr>
              <a:t> </a:t>
            </a:r>
          </a:p>
          <a:p>
            <a:pPr algn="ctr"/>
            <a:r>
              <a:rPr lang="en-US" sz="900" dirty="0">
                <a:solidFill>
                  <a:prstClr val="black"/>
                </a:solidFill>
              </a:rPr>
              <a:t>on </a:t>
            </a:r>
            <a:r>
              <a:rPr lang="en-US" sz="900" dirty="0" err="1">
                <a:solidFill>
                  <a:prstClr val="black"/>
                </a:solidFill>
              </a:rPr>
              <a:t>coverglass</a:t>
            </a:r>
            <a:endParaRPr lang="en-US" sz="900" dirty="0">
              <a:solidFill>
                <a:prstClr val="black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038725" y="1131986"/>
            <a:ext cx="10023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</a:rPr>
              <a:t>Invasive hyphae</a:t>
            </a:r>
          </a:p>
        </p:txBody>
      </p:sp>
      <p:pic>
        <p:nvPicPr>
          <p:cNvPr id="42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2007" y="3317003"/>
            <a:ext cx="874854" cy="496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4463" y="3823876"/>
            <a:ext cx="872398" cy="492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4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48"/>
          <a:stretch/>
        </p:blipFill>
        <p:spPr bwMode="auto">
          <a:xfrm>
            <a:off x="1744815" y="4326742"/>
            <a:ext cx="872045" cy="4973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Picture 5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6995" y="3317874"/>
            <a:ext cx="1002311" cy="496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6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6994" y="3823979"/>
            <a:ext cx="1002311" cy="4926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Picture 7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6995" y="4326742"/>
            <a:ext cx="1002311" cy="4973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" name="Picture 8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2534" y="3317003"/>
            <a:ext cx="1377492" cy="49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" name="Picture 9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2534" y="3823980"/>
            <a:ext cx="1377491" cy="492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4" name="Picture 10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2534" y="4326742"/>
            <a:ext cx="1377491" cy="497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" name="Picture 11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044556" y="3128526"/>
            <a:ext cx="496153" cy="8748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7" name="Picture 12"/>
          <p:cNvPicPr>
            <a:picLocks noChangeAspect="1" noChangeArrowheads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86"/>
          <a:stretch/>
        </p:blipFill>
        <p:spPr bwMode="auto">
          <a:xfrm rot="5400000">
            <a:off x="1047314" y="3632805"/>
            <a:ext cx="492710" cy="8748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Picture 13"/>
          <p:cNvPicPr>
            <a:picLocks noChangeAspect="1" noChangeArrowheads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92" t="1101" r="3310" b="574"/>
          <a:stretch/>
        </p:blipFill>
        <p:spPr bwMode="auto">
          <a:xfrm rot="5400000">
            <a:off x="1043484" y="4137840"/>
            <a:ext cx="498299" cy="87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" name="Picture 2"/>
          <p:cNvPicPr>
            <a:picLocks noChangeAspect="1" noChangeArrowheads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00" t="2110" r="-1" b="2710"/>
          <a:stretch/>
        </p:blipFill>
        <p:spPr bwMode="auto">
          <a:xfrm rot="16200000">
            <a:off x="4276556" y="3070281"/>
            <a:ext cx="496153" cy="9913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2" name="Picture 3"/>
          <p:cNvPicPr>
            <a:picLocks noChangeAspect="1" noChangeArrowheads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2" r="-1" b="2112"/>
          <a:stretch/>
        </p:blipFill>
        <p:spPr bwMode="auto">
          <a:xfrm rot="16200000">
            <a:off x="4278280" y="3574559"/>
            <a:ext cx="492712" cy="9913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3" name="Picture 4"/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275952" y="4079755"/>
            <a:ext cx="497364" cy="99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5" name="TextBox 64"/>
          <p:cNvSpPr txBox="1"/>
          <p:nvPr/>
        </p:nvSpPr>
        <p:spPr>
          <a:xfrm>
            <a:off x="292839" y="3509391"/>
            <a:ext cx="51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Merge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94744" y="3900479"/>
            <a:ext cx="791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RP27p:</a:t>
            </a:r>
          </a:p>
          <a:p>
            <a:r>
              <a:rPr lang="en-US" sz="900" dirty="0" err="1"/>
              <a:t>tdTomato</a:t>
            </a:r>
            <a:endParaRPr lang="en-US" sz="900" dirty="0"/>
          </a:p>
        </p:txBody>
      </p:sp>
      <p:sp>
        <p:nvSpPr>
          <p:cNvPr id="67" name="TextBox 66"/>
          <p:cNvSpPr txBox="1"/>
          <p:nvPr/>
        </p:nvSpPr>
        <p:spPr>
          <a:xfrm>
            <a:off x="294744" y="4390423"/>
            <a:ext cx="672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PWL2p:</a:t>
            </a:r>
          </a:p>
          <a:p>
            <a:r>
              <a:rPr lang="en-US" sz="900" dirty="0"/>
              <a:t>EGFP</a:t>
            </a:r>
          </a:p>
        </p:txBody>
      </p:sp>
      <p:pic>
        <p:nvPicPr>
          <p:cNvPr id="60" name="Picture 3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274208" y="1724899"/>
            <a:ext cx="496642" cy="99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4" name="Picture 4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276944" y="2231141"/>
            <a:ext cx="491169" cy="995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3"/>
          <p:cNvPicPr>
            <a:picLocks noChangeAspect="1" noChangeArrowheads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044312" y="1785252"/>
            <a:ext cx="496644" cy="8748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0" name="TextBox 69"/>
          <p:cNvSpPr txBox="1"/>
          <p:nvPr/>
        </p:nvSpPr>
        <p:spPr>
          <a:xfrm rot="16200000">
            <a:off x="5496676" y="2074021"/>
            <a:ext cx="1475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Optimal setting</a:t>
            </a:r>
          </a:p>
        </p:txBody>
      </p:sp>
      <p:cxnSp>
        <p:nvCxnSpPr>
          <p:cNvPr id="71" name="Straight Connector 70"/>
          <p:cNvCxnSpPr/>
          <p:nvPr/>
        </p:nvCxnSpPr>
        <p:spPr>
          <a:xfrm>
            <a:off x="6074161" y="1465005"/>
            <a:ext cx="0" cy="15087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 rot="16200000">
            <a:off x="5390069" y="3929958"/>
            <a:ext cx="1673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ighly sensitive setting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6071795" y="3310501"/>
            <a:ext cx="0" cy="15087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D8FDBAFD-59D8-4784-8B4E-9E3DDB080EA5}"/>
              </a:ext>
            </a:extLst>
          </p:cNvPr>
          <p:cNvSpPr txBox="1"/>
          <p:nvPr/>
        </p:nvSpPr>
        <p:spPr>
          <a:xfrm>
            <a:off x="280670" y="944901"/>
            <a:ext cx="3813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8FDBAFD-59D8-4784-8B4E-9E3DDB080EA5}"/>
              </a:ext>
            </a:extLst>
          </p:cNvPr>
          <p:cNvSpPr txBox="1"/>
          <p:nvPr/>
        </p:nvSpPr>
        <p:spPr>
          <a:xfrm>
            <a:off x="290848" y="2999993"/>
            <a:ext cx="383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82080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28</TotalTime>
  <Words>44</Words>
  <Application>Microsoft Macintosh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Georgi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e Zhu</dc:creator>
  <cp:lastModifiedBy>Anon</cp:lastModifiedBy>
  <cp:revision>1200</cp:revision>
  <cp:lastPrinted>2020-03-02T17:55:46Z</cp:lastPrinted>
  <dcterms:created xsi:type="dcterms:W3CDTF">2019-02-08T19:32:18Z</dcterms:created>
  <dcterms:modified xsi:type="dcterms:W3CDTF">2020-10-22T07:32:09Z</dcterms:modified>
</cp:coreProperties>
</file>